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8999538" cy="7199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1273" autoAdjust="0"/>
  </p:normalViewPr>
  <p:slideViewPr>
    <p:cSldViewPr snapToGrid="0">
      <p:cViewPr varScale="1">
        <p:scale>
          <a:sx n="93" d="100"/>
          <a:sy n="93" d="100"/>
        </p:scale>
        <p:origin x="212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임승혁" userId="50080d77-0d6e-4880-96a7-58e4dd6aba5c" providerId="ADAL" clId="{E599F318-C71D-4FAB-87F3-03E31BE481F1}"/>
    <pc:docChg chg="undo custSel modSld">
      <pc:chgData name="임승혁" userId="50080d77-0d6e-4880-96a7-58e4dd6aba5c" providerId="ADAL" clId="{E599F318-C71D-4FAB-87F3-03E31BE481F1}" dt="2023-05-09T01:51:38.947" v="137" actId="20577"/>
      <pc:docMkLst>
        <pc:docMk/>
      </pc:docMkLst>
      <pc:sldChg chg="addSp delSp modSp mod">
        <pc:chgData name="임승혁" userId="50080d77-0d6e-4880-96a7-58e4dd6aba5c" providerId="ADAL" clId="{E599F318-C71D-4FAB-87F3-03E31BE481F1}" dt="2023-05-09T01:51:38.947" v="137" actId="20577"/>
        <pc:sldMkLst>
          <pc:docMk/>
          <pc:sldMk cId="3431822228" sldId="256"/>
        </pc:sldMkLst>
        <pc:spChg chg="add del">
          <ac:chgData name="임승혁" userId="50080d77-0d6e-4880-96a7-58e4dd6aba5c" providerId="ADAL" clId="{E599F318-C71D-4FAB-87F3-03E31BE481F1}" dt="2023-05-09T01:50:33.145" v="1" actId="22"/>
          <ac:spMkLst>
            <pc:docMk/>
            <pc:sldMk cId="3431822228" sldId="256"/>
            <ac:spMk id="3" creationId="{C8291122-1E44-B11F-E735-083DE5CA7EBC}"/>
          </ac:spMkLst>
        </pc:spChg>
        <pc:spChg chg="mod">
          <ac:chgData name="임승혁" userId="50080d77-0d6e-4880-96a7-58e4dd6aba5c" providerId="ADAL" clId="{E599F318-C71D-4FAB-87F3-03E31BE481F1}" dt="2023-05-09T01:51:01.765" v="95" actId="404"/>
          <ac:spMkLst>
            <pc:docMk/>
            <pc:sldMk cId="3431822228" sldId="256"/>
            <ac:spMk id="5" creationId="{A2B06BF4-8BA6-EA6E-3403-93919840A4E6}"/>
          </ac:spMkLst>
        </pc:spChg>
        <pc:spChg chg="mod">
          <ac:chgData name="임승혁" userId="50080d77-0d6e-4880-96a7-58e4dd6aba5c" providerId="ADAL" clId="{E599F318-C71D-4FAB-87F3-03E31BE481F1}" dt="2023-05-09T01:51:38.947" v="137" actId="20577"/>
          <ac:spMkLst>
            <pc:docMk/>
            <pc:sldMk cId="3431822228" sldId="256"/>
            <ac:spMk id="6" creationId="{BF25BFE9-B681-C1BE-A27A-ABB17CCE3961}"/>
          </ac:spMkLst>
        </pc:spChg>
        <pc:picChg chg="mod">
          <ac:chgData name="임승혁" userId="50080d77-0d6e-4880-96a7-58e4dd6aba5c" providerId="ADAL" clId="{E599F318-C71D-4FAB-87F3-03E31BE481F1}" dt="2023-05-09T01:51:07.792" v="96" actId="14826"/>
          <ac:picMkLst>
            <pc:docMk/>
            <pc:sldMk cId="3431822228" sldId="256"/>
            <ac:picMk id="4" creationId="{5128FDE4-C49C-3003-319C-CA1C90D4F163}"/>
          </ac:picMkLst>
        </pc:picChg>
      </pc:sldChg>
    </pc:docChg>
  </pc:docChgLst>
  <pc:docChgLst>
    <pc:chgData name="임승혁" userId="50080d77-0d6e-4880-96a7-58e4dd6aba5c" providerId="ADAL" clId="{1C1D2D21-FB0F-4926-AC93-4D40129D0E05}"/>
    <pc:docChg chg="modSld">
      <pc:chgData name="임승혁" userId="50080d77-0d6e-4880-96a7-58e4dd6aba5c" providerId="ADAL" clId="{1C1D2D21-FB0F-4926-AC93-4D40129D0E05}" dt="2023-07-03T03:09:10.791" v="5" actId="20577"/>
      <pc:docMkLst>
        <pc:docMk/>
      </pc:docMkLst>
      <pc:sldChg chg="modSp mod">
        <pc:chgData name="임승혁" userId="50080d77-0d6e-4880-96a7-58e4dd6aba5c" providerId="ADAL" clId="{1C1D2D21-FB0F-4926-AC93-4D40129D0E05}" dt="2023-07-03T03:09:10.791" v="5" actId="20577"/>
        <pc:sldMkLst>
          <pc:docMk/>
          <pc:sldMk cId="3431822228" sldId="256"/>
        </pc:sldMkLst>
        <pc:spChg chg="mod">
          <ac:chgData name="임승혁" userId="50080d77-0d6e-4880-96a7-58e4dd6aba5c" providerId="ADAL" clId="{1C1D2D21-FB0F-4926-AC93-4D40129D0E05}" dt="2023-07-03T03:09:10.791" v="5" actId="20577"/>
          <ac:spMkLst>
            <pc:docMk/>
            <pc:sldMk cId="3431822228" sldId="256"/>
            <ac:spMk id="5" creationId="{A2B06BF4-8BA6-EA6E-3403-93919840A4E6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12A8ACC-800C-411D-A947-8DB322DD5BD6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500188" y="1143000"/>
            <a:ext cx="38576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55FC58-540C-479B-B142-3AE2D6087C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004222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55FC58-540C-479B-B142-3AE2D6087CD7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769765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1178222"/>
            <a:ext cx="7649607" cy="2506427"/>
          </a:xfrm>
        </p:spPr>
        <p:txBody>
          <a:bodyPr anchor="b"/>
          <a:lstStyle>
            <a:lvl1pPr algn="ctr">
              <a:defRPr sz="5905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3781306"/>
            <a:ext cx="6749654" cy="1738167"/>
          </a:xfrm>
        </p:spPr>
        <p:txBody>
          <a:bodyPr/>
          <a:lstStyle>
            <a:lvl1pPr marL="0" indent="0" algn="ctr">
              <a:buNone/>
              <a:defRPr sz="2362"/>
            </a:lvl1pPr>
            <a:lvl2pPr marL="449976" indent="0" algn="ctr">
              <a:buNone/>
              <a:defRPr sz="1968"/>
            </a:lvl2pPr>
            <a:lvl3pPr marL="899952" indent="0" algn="ctr">
              <a:buNone/>
              <a:defRPr sz="1772"/>
            </a:lvl3pPr>
            <a:lvl4pPr marL="1349929" indent="0" algn="ctr">
              <a:buNone/>
              <a:defRPr sz="1575"/>
            </a:lvl4pPr>
            <a:lvl5pPr marL="1799905" indent="0" algn="ctr">
              <a:buNone/>
              <a:defRPr sz="1575"/>
            </a:lvl5pPr>
            <a:lvl6pPr marL="2249881" indent="0" algn="ctr">
              <a:buNone/>
              <a:defRPr sz="1575"/>
            </a:lvl6pPr>
            <a:lvl7pPr marL="2699857" indent="0" algn="ctr">
              <a:buNone/>
              <a:defRPr sz="1575"/>
            </a:lvl7pPr>
            <a:lvl8pPr marL="3149834" indent="0" algn="ctr">
              <a:buNone/>
              <a:defRPr sz="1575"/>
            </a:lvl8pPr>
            <a:lvl9pPr marL="3599810" indent="0" algn="ctr">
              <a:buNone/>
              <a:defRPr sz="1575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679152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4385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383297"/>
            <a:ext cx="1940525" cy="610108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9" y="383297"/>
            <a:ext cx="5709082" cy="610108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53249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21691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1794831"/>
            <a:ext cx="7762102" cy="2994714"/>
          </a:xfrm>
        </p:spPr>
        <p:txBody>
          <a:bodyPr anchor="b"/>
          <a:lstStyle>
            <a:lvl1pPr>
              <a:defRPr sz="5905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4817876"/>
            <a:ext cx="7762102" cy="1574849"/>
          </a:xfrm>
        </p:spPr>
        <p:txBody>
          <a:bodyPr/>
          <a:lstStyle>
            <a:lvl1pPr marL="0" indent="0">
              <a:buNone/>
              <a:defRPr sz="2362">
                <a:solidFill>
                  <a:schemeClr val="tx1"/>
                </a:solidFill>
              </a:defRPr>
            </a:lvl1pPr>
            <a:lvl2pPr marL="449976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2pPr>
            <a:lvl3pPr marL="899952" indent="0">
              <a:buNone/>
              <a:defRPr sz="1772">
                <a:solidFill>
                  <a:schemeClr val="tx1">
                    <a:tint val="75000"/>
                  </a:schemeClr>
                </a:solidFill>
              </a:defRPr>
            </a:lvl3pPr>
            <a:lvl4pPr marL="1349929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4pPr>
            <a:lvl5pPr marL="179990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5pPr>
            <a:lvl6pPr marL="2249881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6pPr>
            <a:lvl7pPr marL="2699857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7pPr>
            <a:lvl8pPr marL="314983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8pPr>
            <a:lvl9pPr marL="3599810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28316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1916484"/>
            <a:ext cx="3824804" cy="456789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1916484"/>
            <a:ext cx="3824804" cy="456789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64022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383299"/>
            <a:ext cx="7762102" cy="1391534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1764832"/>
            <a:ext cx="3807226" cy="864917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2629749"/>
            <a:ext cx="3807226" cy="3867965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7" y="1764832"/>
            <a:ext cx="3825976" cy="864917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7" y="2629749"/>
            <a:ext cx="3825976" cy="3867965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73475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41789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841783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479954"/>
            <a:ext cx="2902585" cy="167984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1036570"/>
            <a:ext cx="4556016" cy="5116178"/>
          </a:xfrm>
        </p:spPr>
        <p:txBody>
          <a:bodyPr/>
          <a:lstStyle>
            <a:lvl1pPr>
              <a:defRPr sz="3149"/>
            </a:lvl1pPr>
            <a:lvl2pPr>
              <a:defRPr sz="2756"/>
            </a:lvl2pPr>
            <a:lvl3pPr>
              <a:defRPr sz="2362"/>
            </a:lvl3pPr>
            <a:lvl4pPr>
              <a:defRPr sz="1968"/>
            </a:lvl4pPr>
            <a:lvl5pPr>
              <a:defRPr sz="1968"/>
            </a:lvl5pPr>
            <a:lvl6pPr>
              <a:defRPr sz="1968"/>
            </a:lvl6pPr>
            <a:lvl7pPr>
              <a:defRPr sz="1968"/>
            </a:lvl7pPr>
            <a:lvl8pPr>
              <a:defRPr sz="1968"/>
            </a:lvl8pPr>
            <a:lvl9pPr>
              <a:defRPr sz="1968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2159794"/>
            <a:ext cx="2902585" cy="4001285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413870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479954"/>
            <a:ext cx="2902585" cy="167984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1036570"/>
            <a:ext cx="4556016" cy="5116178"/>
          </a:xfrm>
        </p:spPr>
        <p:txBody>
          <a:bodyPr anchor="t"/>
          <a:lstStyle>
            <a:lvl1pPr marL="0" indent="0">
              <a:buNone/>
              <a:defRPr sz="3149"/>
            </a:lvl1pPr>
            <a:lvl2pPr marL="449976" indent="0">
              <a:buNone/>
              <a:defRPr sz="2756"/>
            </a:lvl2pPr>
            <a:lvl3pPr marL="899952" indent="0">
              <a:buNone/>
              <a:defRPr sz="2362"/>
            </a:lvl3pPr>
            <a:lvl4pPr marL="1349929" indent="0">
              <a:buNone/>
              <a:defRPr sz="1968"/>
            </a:lvl4pPr>
            <a:lvl5pPr marL="1799905" indent="0">
              <a:buNone/>
              <a:defRPr sz="1968"/>
            </a:lvl5pPr>
            <a:lvl6pPr marL="2249881" indent="0">
              <a:buNone/>
              <a:defRPr sz="1968"/>
            </a:lvl6pPr>
            <a:lvl7pPr marL="2699857" indent="0">
              <a:buNone/>
              <a:defRPr sz="1968"/>
            </a:lvl7pPr>
            <a:lvl8pPr marL="3149834" indent="0">
              <a:buNone/>
              <a:defRPr sz="1968"/>
            </a:lvl8pPr>
            <a:lvl9pPr marL="3599810" indent="0">
              <a:buNone/>
              <a:defRPr sz="1968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2159794"/>
            <a:ext cx="2902585" cy="4001285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17591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383299"/>
            <a:ext cx="7762102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1916484"/>
            <a:ext cx="7762102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6672698"/>
            <a:ext cx="2024896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6672698"/>
            <a:ext cx="3037344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6672698"/>
            <a:ext cx="2024896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53360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899952" rtl="0" eaLnBrk="1" latinLnBrk="1" hangingPunct="1">
        <a:lnSpc>
          <a:spcPct val="90000"/>
        </a:lnSpc>
        <a:spcBef>
          <a:spcPct val="0"/>
        </a:spcBef>
        <a:buNone/>
        <a:defRPr sz="43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4988" indent="-224988" algn="l" defTabSz="899952" rtl="0" eaLnBrk="1" latinLnBrk="1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1pPr>
      <a:lvl2pPr marL="674964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24941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968" kern="1200">
          <a:solidFill>
            <a:schemeClr val="tx1"/>
          </a:solidFill>
          <a:latin typeface="+mn-lt"/>
          <a:ea typeface="+mn-ea"/>
          <a:cs typeface="+mn-cs"/>
        </a:defRPr>
      </a:lvl3pPr>
      <a:lvl4pPr marL="1574917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2024893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474869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924846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374822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824798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1pPr>
      <a:lvl2pPr marL="449976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899952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349929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1799905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249881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699857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149834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599810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5128FDE4-C49C-3003-319C-CA1C90D4F16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21" b="1921"/>
          <a:stretch/>
        </p:blipFill>
        <p:spPr bwMode="auto">
          <a:xfrm>
            <a:off x="976045" y="904125"/>
            <a:ext cx="7037798" cy="5802949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2B06BF4-8BA6-EA6E-3403-93919840A4E6}"/>
              </a:ext>
            </a:extLst>
          </p:cNvPr>
          <p:cNvSpPr txBox="1"/>
          <p:nvPr/>
        </p:nvSpPr>
        <p:spPr>
          <a:xfrm>
            <a:off x="134936" y="81137"/>
            <a:ext cx="8753273" cy="6994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4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mental Digital </a:t>
            </a:r>
            <a:r>
              <a:rPr lang="en-US" altLang="ko-KR" sz="1400" b="1" kern="10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ontent 5. </a:t>
            </a:r>
            <a:r>
              <a:rPr lang="en-US" altLang="ko-KR" sz="14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Post-transplantation survival after </a:t>
            </a:r>
            <a:r>
              <a:rPr lang="en-US" altLang="ko-KR" sz="1400" b="1" kern="1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living-donor</a:t>
            </a:r>
            <a:r>
              <a:rPr lang="ko-KR" altLang="en-US" sz="1400" b="1" kern="1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400" b="1" kern="1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liver</a:t>
            </a:r>
            <a:r>
              <a:rPr lang="ko-KR" altLang="en-US" sz="1400" b="1" kern="1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400" b="1" kern="1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ransplantation</a:t>
            </a:r>
            <a:r>
              <a:rPr lang="en-US" altLang="ko-KR" sz="14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and deceased-donor liver transplantation.</a:t>
            </a:r>
            <a:endParaRPr lang="ko-KR" altLang="ko-KR" sz="14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F25BFE9-B681-C1BE-A27A-ABB17CCE3961}"/>
              </a:ext>
            </a:extLst>
          </p:cNvPr>
          <p:cNvSpPr txBox="1"/>
          <p:nvPr/>
        </p:nvSpPr>
        <p:spPr>
          <a:xfrm>
            <a:off x="134936" y="6769335"/>
            <a:ext cx="8753273" cy="3191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latinLnBrk="1">
              <a:lnSpc>
                <a:spcPct val="150000"/>
              </a:lnSpc>
              <a:spcAft>
                <a:spcPts val="800"/>
              </a:spcAft>
            </a:pPr>
            <a:r>
              <a:rPr lang="en-US" altLang="ko-KR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LDLT, living-donor liver transplantation; DDLT, Deceased-donor liver transplantation; LT, </a:t>
            </a:r>
            <a:r>
              <a:rPr lang="en-US" altLang="ko-KR" sz="1100" kern="1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liver transplantation.</a:t>
            </a:r>
            <a:endParaRPr lang="ko-KR" altLang="ko-KR" sz="1050" kern="100" dirty="0">
              <a:effectLst/>
              <a:latin typeface="Calibri" panose="020F050202020403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ACE8C632-8FAA-0062-92DC-0D02AE043F86}"/>
              </a:ext>
            </a:extLst>
          </p:cNvPr>
          <p:cNvCxnSpPr/>
          <p:nvPr/>
        </p:nvCxnSpPr>
        <p:spPr>
          <a:xfrm>
            <a:off x="134936" y="6769335"/>
            <a:ext cx="849535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318222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3</TotalTime>
  <Words>34</Words>
  <Application>Microsoft Office PowerPoint</Application>
  <PresentationFormat>사용자 지정</PresentationFormat>
  <Paragraphs>3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Yim Seung Hyuk</dc:creator>
  <cp:lastModifiedBy>임승혁</cp:lastModifiedBy>
  <cp:revision>2</cp:revision>
  <dcterms:created xsi:type="dcterms:W3CDTF">2023-05-09T01:23:50Z</dcterms:created>
  <dcterms:modified xsi:type="dcterms:W3CDTF">2023-07-03T03:09:11Z</dcterms:modified>
</cp:coreProperties>
</file>